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png" ContentType="image/png"/>
  <Override PartName="/ppt/media/image8.wmf" ContentType="image/x-wmf"/>
  <Override PartName="/ppt/media/image10.png" ContentType="image/png"/>
  <Override PartName="/ppt/media/image5.wmf" ContentType="image/x-wmf"/>
  <Override PartName="/ppt/media/image9.wmf" ContentType="image/x-wmf"/>
  <Override PartName="/ppt/media/image14.png" ContentType="image/png"/>
  <Override PartName="/ppt/media/image12.png" ContentType="image/png"/>
  <Override PartName="/ppt/media/image7.png" ContentType="image/png"/>
  <Override PartName="/ppt/media/image15.wmf" ContentType="image/x-wmf"/>
  <Override PartName="/ppt/media/image6.wmf" ContentType="image/x-wmf"/>
  <Override PartName="/ppt/media/image11.png" ContentType="image/png"/>
  <Override PartName="/ppt/media/image4.png" ContentType="image/png"/>
  <Override PartName="/ppt/media/image3.png" ContentType="image/png"/>
  <Override PartName="/ppt/media/image26.png" ContentType="image/png"/>
  <Override PartName="/ppt/media/image27.wmf" ContentType="image/x-wmf"/>
  <Override PartName="/ppt/media/image25.wmf" ContentType="image/x-wmf"/>
  <Override PartName="/ppt/media/image23.wmf" ContentType="image/x-wmf"/>
  <Override PartName="/ppt/media/image22.wmf" ContentType="image/x-wmf"/>
  <Override PartName="/ppt/media/image21.wmf" ContentType="image/x-wmf"/>
  <Override PartName="/ppt/media/image19.wmf" ContentType="image/x-wmf"/>
  <Override PartName="/ppt/media/image2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wmf" ContentType="image/x-wmf"/>
  <Override PartName="/ppt/media/image1.wmf" ContentType="image/x-wmf"/>
  <Override PartName="/ppt/media/image24.wmf" ContentType="image/x-wmf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75AC07-3AD6-41D6-B75E-6828D7CCF77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C885EF-C53C-4C80-A1C9-34C31A2E84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212B65-E866-433C-846A-A96CAD75EC4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FD4370-5EE5-4195-8CB5-B0C3C5FAF66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B3A4D4-3131-44ED-AB85-E48328023D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D032CF-19BC-4E6F-8C18-0F90E7E60B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A7D75F-480A-4A5A-BCAB-83CA9FD174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1DA5EE-C078-4A46-BE39-C35EB918B4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FEDBA1-E47A-4604-B916-7367017853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E89208-0BED-4F03-8A7A-D74574C5F2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503038-520F-4439-B186-9A80E21DC7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EE6036-A0EA-4AFC-AC6F-649C1B8C4D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A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6B9E50-CA57-4DDC-9D97-5D3CCC930D71}" type="slidenum">
              <a:rPr b="0" lang="de-A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7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5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6.wmf"/><Relationship Id="rId5" Type="http://schemas.openxmlformats.org/officeDocument/2006/relationships/image" Target="../media/image7.png"/><Relationship Id="rId6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image" Target="../media/image9.wmf"/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6" Type="http://schemas.openxmlformats.org/officeDocument/2006/relationships/image" Target="../media/image13.png"/><Relationship Id="rId7" Type="http://schemas.openxmlformats.org/officeDocument/2006/relationships/image" Target="../media/image14.png"/><Relationship Id="rId8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image" Target="../media/image16.wmf"/><Relationship Id="rId3" Type="http://schemas.openxmlformats.org/officeDocument/2006/relationships/image" Target="../media/image17.png"/><Relationship Id="rId4" Type="http://schemas.openxmlformats.org/officeDocument/2006/relationships/image" Target="../media/image18.png"/><Relationship Id="rId5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9.wmf"/><Relationship Id="rId2" Type="http://schemas.openxmlformats.org/officeDocument/2006/relationships/image" Target="../media/image20.png"/><Relationship Id="rId3" Type="http://schemas.openxmlformats.org/officeDocument/2006/relationships/image" Target="../media/image20.png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2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2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25.wmf"/><Relationship Id="rId11" Type="http://schemas.openxmlformats.org/officeDocument/2006/relationships/image" Target="../media/image26.png"/><Relationship Id="rId1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7"/>
          <p:cNvSpPr/>
          <p:nvPr/>
        </p:nvSpPr>
        <p:spPr>
          <a:xfrm>
            <a:off x="1206360" y="6170760"/>
            <a:ext cx="5510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 S1. List of  chemical inhibitors utilized in the current study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10" descr=""/>
          <p:cNvPicPr/>
          <p:nvPr/>
        </p:nvPicPr>
        <p:blipFill>
          <a:blip r:embed="rId1"/>
          <a:stretch/>
        </p:blipFill>
        <p:spPr>
          <a:xfrm>
            <a:off x="1495440" y="1735200"/>
            <a:ext cx="3838680" cy="4319640"/>
          </a:xfrm>
          <a:prstGeom prst="rect">
            <a:avLst/>
          </a:prstGeom>
          <a:ln w="0">
            <a:noFill/>
          </a:ln>
        </p:spPr>
      </p:pic>
      <p:sp>
        <p:nvSpPr>
          <p:cNvPr id="43" name="TextBox 1"/>
          <p:cNvSpPr/>
          <p:nvPr/>
        </p:nvSpPr>
        <p:spPr>
          <a:xfrm>
            <a:off x="11520" y="492120"/>
            <a:ext cx="2719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Informa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Text Box 4"/>
          <p:cNvSpPr/>
          <p:nvPr/>
        </p:nvSpPr>
        <p:spPr>
          <a:xfrm>
            <a:off x="0" y="2852640"/>
            <a:ext cx="679464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6. PLK inhibition overcomes MITF-mediated intrinsic resistance. 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MEL-B and HMEL-B/M cells were treated for 24 hours with PLK1 inhibitor BI-2536 (20 nM) followed by the assessment of cell viability relative to DMSO control 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(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n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=3)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3" name="Object 4"/>
          <p:cNvGraphicFramePr/>
          <p:nvPr/>
        </p:nvGraphicFramePr>
        <p:xfrm>
          <a:off x="2666880" y="1262160"/>
          <a:ext cx="1762200" cy="11635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14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666880" y="1262160"/>
                    <a:ext cx="1762200" cy="1163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3" descr=""/>
          <p:cNvPicPr/>
          <p:nvPr/>
        </p:nvPicPr>
        <p:blipFill>
          <a:blip r:embed="rId1"/>
          <a:stretch/>
        </p:blipFill>
        <p:spPr>
          <a:xfrm>
            <a:off x="1185840" y="1500120"/>
            <a:ext cx="4435560" cy="6243840"/>
          </a:xfrm>
          <a:prstGeom prst="rect">
            <a:avLst/>
          </a:prstGeom>
          <a:ln w="0">
            <a:noFill/>
          </a:ln>
        </p:spPr>
      </p:pic>
      <p:sp>
        <p:nvSpPr>
          <p:cNvPr id="45" name="Text Box 7"/>
          <p:cNvSpPr/>
          <p:nvPr/>
        </p:nvSpPr>
        <p:spPr>
          <a:xfrm>
            <a:off x="115920" y="8016840"/>
            <a:ext cx="6742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 S2. iTRAQ-generated list of  kinases showing differential affinities for Midostaurin (Mido) and Sunitinib (Suni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2" descr=""/>
          <p:cNvPicPr/>
          <p:nvPr/>
        </p:nvPicPr>
        <p:blipFill>
          <a:blip r:embed="rId1"/>
          <a:stretch/>
        </p:blipFill>
        <p:spPr>
          <a:xfrm>
            <a:off x="1066680" y="2398680"/>
            <a:ext cx="4543560" cy="4167360"/>
          </a:xfrm>
          <a:prstGeom prst="rect">
            <a:avLst/>
          </a:prstGeom>
          <a:ln w="0">
            <a:noFill/>
          </a:ln>
        </p:spPr>
      </p:pic>
      <p:sp>
        <p:nvSpPr>
          <p:cNvPr id="47" name="Text Box 7"/>
          <p:cNvSpPr/>
          <p:nvPr/>
        </p:nvSpPr>
        <p:spPr>
          <a:xfrm>
            <a:off x="115920" y="6966000"/>
            <a:ext cx="6742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 S3.  (1D) LC-MS-generated list of  kinases showing highest affinities for Midostaurin (Mido) and Sunitinib (Suni). pc – peptide count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6"/>
          <p:cNvSpPr/>
          <p:nvPr/>
        </p:nvSpPr>
        <p:spPr>
          <a:xfrm>
            <a:off x="0" y="3538440"/>
            <a:ext cx="67420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 S4.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utational status of key molecules in the utilized melanoma cell lines.  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D: homozygous deletion; PM: point mutation; WT: wild-type; ND: not determined; NF: non functional. Courtesy: sangar.ac.uk, cansar.icr.ac.uk, Wistar Institute, Philadelphia, PA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4" descr=""/>
          <p:cNvPicPr/>
          <p:nvPr/>
        </p:nvPicPr>
        <p:blipFill>
          <a:blip r:embed="rId1"/>
          <a:srcRect l="0" t="0" r="0" b="20720"/>
          <a:stretch/>
        </p:blipFill>
        <p:spPr>
          <a:xfrm>
            <a:off x="209520" y="1409760"/>
            <a:ext cx="6343560" cy="1962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Object 9"/>
          <p:cNvGraphicFramePr/>
          <p:nvPr/>
        </p:nvGraphicFramePr>
        <p:xfrm>
          <a:off x="1376280" y="1481040"/>
          <a:ext cx="1787760" cy="13273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1" name="Object 9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376280" y="1481040"/>
                    <a:ext cx="1787760" cy="1327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2" name="Object 10"/>
          <p:cNvGraphicFramePr/>
          <p:nvPr/>
        </p:nvGraphicFramePr>
        <p:xfrm>
          <a:off x="3535200" y="1465200"/>
          <a:ext cx="1997280" cy="13413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3" name="Object 10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535200" y="1465200"/>
                    <a:ext cx="1997280" cy="1341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4" name="Text Box 7"/>
          <p:cNvSpPr/>
          <p:nvPr/>
        </p:nvSpPr>
        <p:spPr>
          <a:xfrm>
            <a:off x="0" y="4280040"/>
            <a:ext cx="6858000" cy="161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1. MITF confers sensitivity to MAPK inhibitors in melanocytes. 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HMEL-B and HMEL-B/M cells were treated as indicated for 24 hours followed by the  assessment of viability relative to DMSO control. </a:t>
            </a:r>
            <a:r>
              <a:rPr b="0" i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te: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he observed increased viability in HMEL-B/M cells precluded the inclusion of this data in Fig. 1B. (</a:t>
            </a: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HMEL-B and HMEL-B/M cells were treated with distinct MAPK pathway inhibitors (BRAF inhibitors: GDC-0879 (1 µM), PLX-4032 (1 µM); MEK inhibitors: CI-1040 (1 µM) PD98059 (1 µM); CRAF inhibitor: Sorafenib (5 µM) for 24 hours followed by the assessment of cell viability relative to DMSO control. (</a:t>
            </a: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UACC-62 and HMEL-B/M cells were treated with DMSO control or the indicated MAPK inhibitors (BRAF inhibitor: PLX-4032 (1 µM); MEK inhibitors: CI-1040 (1 µM), PD98059 (1 µM), and U0126 (1 µM) ) for 24 hours followed by the assessment of indicated proteins by immunoblotting. Refer to Supplementary Table 1 for Drug concentration in (</a:t>
            </a: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and (</a:t>
            </a: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0"/>
          <p:cNvSpPr/>
          <p:nvPr/>
        </p:nvSpPr>
        <p:spPr>
          <a:xfrm>
            <a:off x="1190160" y="123516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1"/>
          <p:cNvSpPr/>
          <p:nvPr/>
        </p:nvSpPr>
        <p:spPr>
          <a:xfrm>
            <a:off x="3255840" y="123516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2"/>
          <p:cNvSpPr/>
          <p:nvPr/>
        </p:nvSpPr>
        <p:spPr>
          <a:xfrm>
            <a:off x="2292480" y="2860560"/>
            <a:ext cx="27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Picture 8" descr=""/>
          <p:cNvPicPr/>
          <p:nvPr/>
        </p:nvPicPr>
        <p:blipFill>
          <a:blip r:embed="rId5"/>
          <a:stretch/>
        </p:blipFill>
        <p:spPr>
          <a:xfrm>
            <a:off x="2509920" y="3124080"/>
            <a:ext cx="2128680" cy="1052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 Box 6"/>
          <p:cNvSpPr/>
          <p:nvPr/>
        </p:nvSpPr>
        <p:spPr>
          <a:xfrm>
            <a:off x="360000" y="58752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7"/>
          <p:cNvSpPr/>
          <p:nvPr/>
        </p:nvSpPr>
        <p:spPr>
          <a:xfrm>
            <a:off x="1992240" y="2476440"/>
            <a:ext cx="25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Picture 12" descr=""/>
          <p:cNvPicPr/>
          <p:nvPr/>
        </p:nvPicPr>
        <p:blipFill>
          <a:blip r:embed="rId1"/>
          <a:stretch/>
        </p:blipFill>
        <p:spPr>
          <a:xfrm>
            <a:off x="1643040" y="5967360"/>
            <a:ext cx="870120" cy="138132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14" descr=""/>
          <p:cNvPicPr/>
          <p:nvPr/>
        </p:nvPicPr>
        <p:blipFill>
          <a:blip r:embed="rId2"/>
          <a:srcRect l="0" t="51419" r="2266" b="0"/>
          <a:stretch/>
        </p:blipFill>
        <p:spPr>
          <a:xfrm>
            <a:off x="1322280" y="4235400"/>
            <a:ext cx="1506600" cy="125100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8" descr=""/>
          <p:cNvPicPr/>
          <p:nvPr/>
        </p:nvPicPr>
        <p:blipFill>
          <a:blip r:embed="rId3"/>
          <a:srcRect l="2752" t="8231" r="3914" b="7394"/>
          <a:stretch/>
        </p:blipFill>
        <p:spPr>
          <a:xfrm>
            <a:off x="582480" y="858960"/>
            <a:ext cx="2640240" cy="133344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9" descr=""/>
          <p:cNvPicPr/>
          <p:nvPr/>
        </p:nvPicPr>
        <p:blipFill>
          <a:blip r:embed="rId4"/>
          <a:srcRect l="2797" t="0" r="6539" b="17279"/>
          <a:stretch/>
        </p:blipFill>
        <p:spPr>
          <a:xfrm>
            <a:off x="3524400" y="809640"/>
            <a:ext cx="2808000" cy="144000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12" descr=""/>
          <p:cNvPicPr/>
          <p:nvPr/>
        </p:nvPicPr>
        <p:blipFill>
          <a:blip r:embed="rId5"/>
          <a:srcRect l="0" t="13050" r="1442" b="0"/>
          <a:stretch/>
        </p:blipFill>
        <p:spPr>
          <a:xfrm>
            <a:off x="3664080" y="6126120"/>
            <a:ext cx="1616040" cy="116856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15" descr=""/>
          <p:cNvPicPr/>
          <p:nvPr/>
        </p:nvPicPr>
        <p:blipFill>
          <a:blip r:embed="rId6"/>
          <a:srcRect l="3441" t="15205" r="3693" b="7909"/>
          <a:stretch/>
        </p:blipFill>
        <p:spPr>
          <a:xfrm>
            <a:off x="2266920" y="2752560"/>
            <a:ext cx="2235240" cy="109872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16" descr=""/>
          <p:cNvPicPr/>
          <p:nvPr/>
        </p:nvPicPr>
        <p:blipFill>
          <a:blip r:embed="rId7"/>
          <a:srcRect l="0" t="14734" r="-927" b="0"/>
          <a:stretch/>
        </p:blipFill>
        <p:spPr>
          <a:xfrm>
            <a:off x="3335400" y="4394160"/>
            <a:ext cx="2322360" cy="1116000"/>
          </a:xfrm>
          <a:prstGeom prst="rect">
            <a:avLst/>
          </a:prstGeom>
          <a:ln w="0">
            <a:noFill/>
          </a:ln>
        </p:spPr>
      </p:pic>
      <p:sp>
        <p:nvSpPr>
          <p:cNvPr id="68" name="Text Box 7"/>
          <p:cNvSpPr/>
          <p:nvPr/>
        </p:nvSpPr>
        <p:spPr>
          <a:xfrm>
            <a:off x="949320" y="4119480"/>
            <a:ext cx="25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7"/>
          <p:cNvSpPr/>
          <p:nvPr/>
        </p:nvSpPr>
        <p:spPr>
          <a:xfrm>
            <a:off x="1241280" y="5781600"/>
            <a:ext cx="25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13"/>
          <p:cNvSpPr/>
          <p:nvPr/>
        </p:nvSpPr>
        <p:spPr>
          <a:xfrm>
            <a:off x="0" y="7512120"/>
            <a:ext cx="685800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2. 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Integrative selection of kinase target(s). 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(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A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) Phase-contrast images of HMEL-B/M and HMEL-B cells, treated as indicated with Midostaurin and Sunitinib for 4 weeks in a soft-agar colony formation assay. (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B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) HMEL-B/M cells were treated as indicated for 4 weeks in a soft-agar colony formation assay followed capturing of images, utilizing a phase-contrast microscope (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n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=3). (Inhibitors: SB415286 for GSK3A; and MLN8237 for AURKA) (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C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) 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Left, 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HMEL-B cells were treated with GSK3A-i (SB415286) and AURKA-i (MLN8237), as indicated, for 4 weeks in a soft-agar colony formation assay followed by colony count (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n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=3); 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Right,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  representative images (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D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) 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Left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, HMEL-B/M cells were treated with DMSO control or an increasing conc. (as indicated) of MLN8237 for 4 weeks in a soft-agar colony formation assay followed by colony count (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n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=3); 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Right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, representative images. All error bars indicate ±SD;  ns-non-significant;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≤ 0.05,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≤ 0.001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Arial"/>
              </a:rPr>
              <a:t>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 Box 6"/>
          <p:cNvSpPr/>
          <p:nvPr/>
        </p:nvSpPr>
        <p:spPr>
          <a:xfrm>
            <a:off x="3081240" y="42084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9"/>
          <p:cNvSpPr/>
          <p:nvPr/>
        </p:nvSpPr>
        <p:spPr>
          <a:xfrm>
            <a:off x="1131840" y="417600"/>
            <a:ext cx="290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11"/>
          <p:cNvSpPr/>
          <p:nvPr/>
        </p:nvSpPr>
        <p:spPr>
          <a:xfrm>
            <a:off x="14400" y="7024680"/>
            <a:ext cx="6794280" cy="2073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3. Role of AURKA in melanoma biology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. 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(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A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) 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dicated melanoma cell lines were treated with DMSO control or MLN8237 (1 µM) for 48 hours followed by AnnexinV/Propidium Iodide (PI) staining. Percentages on the bottom correspond to the early apoptotic (AnnexinV-positive)+late apoptotic (AnnexinV+PI-positive) cells. 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(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B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) Indicated melanoma cell lines were treated with DMSO control or MLN8237 (1 µM) for 48 hours followed by the immunoblotting for APAF-1. (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C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) BRAF inhibitor (PLX-4032)-sensitive (451Lu and WM983B) and the paired resistant (451Lu_BR and WM983B_BR) melanoma cell lines were treated as indicated for 48 hours 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ollowed by AnnexinV/Propidium Iodide (PI) staining. MLN8237 (1 µM) and PLX-4032 (1 µM) were used. Resistant melanoma cells were constantly maintained in RPMI+10% FCS containing 1 µM PLX. (</a:t>
            </a: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Dermal Fibroblast cells FB2003 were treated with DMSO control and the indicated conc. of MLN8237 for 48 hours followed by AnnexinV/Propidium Iodide (PI) staining (</a:t>
            </a: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</a:t>
            </a:r>
            <a:r>
              <a:rPr b="0" i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ft,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Dermal Fibroblast cells FB2003 were treated with MLN8237 as indicated for 24 and 48 hrs followed by the assessment of viability relative to DMSO control 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(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n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=3)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; </a:t>
            </a:r>
            <a:r>
              <a:rPr b="0" i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ight, 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caled comparison to the relative viability of melanoma cell lines and immortalized human melanocytes upon MLN8237 treatment; the last piece of data also shown as Figure 3a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Picture 12" descr=""/>
          <p:cNvPicPr/>
          <p:nvPr/>
        </p:nvPicPr>
        <p:blipFill>
          <a:blip r:embed="rId1"/>
          <a:stretch/>
        </p:blipFill>
        <p:spPr>
          <a:xfrm>
            <a:off x="1300320" y="743040"/>
            <a:ext cx="1438200" cy="2590560"/>
          </a:xfrm>
          <a:prstGeom prst="rect">
            <a:avLst/>
          </a:prstGeom>
          <a:ln w="0">
            <a:noFill/>
          </a:ln>
        </p:spPr>
      </p:pic>
      <p:sp>
        <p:nvSpPr>
          <p:cNvPr id="75" name="Text Box 14"/>
          <p:cNvSpPr/>
          <p:nvPr/>
        </p:nvSpPr>
        <p:spPr>
          <a:xfrm>
            <a:off x="3079800" y="1581120"/>
            <a:ext cx="27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Picture 19" descr=""/>
          <p:cNvPicPr/>
          <p:nvPr/>
        </p:nvPicPr>
        <p:blipFill>
          <a:blip r:embed="rId2"/>
          <a:stretch/>
        </p:blipFill>
        <p:spPr>
          <a:xfrm>
            <a:off x="3446640" y="1757520"/>
            <a:ext cx="2498400" cy="170316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8" descr=""/>
          <p:cNvPicPr/>
          <p:nvPr/>
        </p:nvPicPr>
        <p:blipFill>
          <a:blip r:embed="rId3"/>
          <a:srcRect l="2202" t="3024" r="0" b="4105"/>
          <a:stretch/>
        </p:blipFill>
        <p:spPr>
          <a:xfrm>
            <a:off x="1517760" y="3940200"/>
            <a:ext cx="3833640" cy="2781360"/>
          </a:xfrm>
          <a:prstGeom prst="rect">
            <a:avLst/>
          </a:prstGeom>
          <a:ln w="0">
            <a:noFill/>
          </a:ln>
        </p:spPr>
      </p:pic>
      <p:sp>
        <p:nvSpPr>
          <p:cNvPr id="78" name="Text Box 7"/>
          <p:cNvSpPr/>
          <p:nvPr/>
        </p:nvSpPr>
        <p:spPr>
          <a:xfrm>
            <a:off x="1249200" y="3784680"/>
            <a:ext cx="25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7"/>
          <p:cNvSpPr/>
          <p:nvPr/>
        </p:nvSpPr>
        <p:spPr>
          <a:xfrm>
            <a:off x="1258920" y="5060880"/>
            <a:ext cx="25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Picture 11" descr=""/>
          <p:cNvPicPr/>
          <p:nvPr/>
        </p:nvPicPr>
        <p:blipFill>
          <a:blip r:embed="rId4"/>
          <a:stretch/>
        </p:blipFill>
        <p:spPr>
          <a:xfrm>
            <a:off x="3286080" y="561960"/>
            <a:ext cx="3419640" cy="1009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Text Box 6"/>
          <p:cNvSpPr/>
          <p:nvPr/>
        </p:nvSpPr>
        <p:spPr>
          <a:xfrm>
            <a:off x="63360" y="7238880"/>
            <a:ext cx="679464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4. Role of AURKA in melanoma biology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. 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(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A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) 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indicated melanoma cell lines were tested for migration (</a:t>
            </a:r>
            <a:r>
              <a:rPr b="0" i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ft panel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upon treatment with DMSO control or MLN8237 (40 nM) 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(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n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=3)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See Methods for details. (</a:t>
            </a:r>
            <a:r>
              <a:rPr b="0" i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ddle panel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corresponding cell loading, and (</a:t>
            </a:r>
            <a:r>
              <a:rPr b="0" i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ight panel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the corresponding changes in cell viability (</a:t>
            </a: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Corresponding representative images from the migation assay. 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All error bars indicate ±SD;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Arial"/>
              </a:rPr>
              <a:t>***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Arial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Arial"/>
              </a:rPr>
              <a:t> ≤ 0.001</a:t>
            </a:r>
            <a:r>
              <a:rPr b="0" lang="de-AT" sz="1000" spc="-1" strike="noStrike">
                <a:solidFill>
                  <a:srgbClr val="000000"/>
                </a:solidFill>
                <a:latin typeface="Times New Roman"/>
                <a:ea typeface="Arial"/>
              </a:rPr>
              <a:t>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Picture 9" descr=""/>
          <p:cNvPicPr/>
          <p:nvPr/>
        </p:nvPicPr>
        <p:blipFill>
          <a:blip r:embed="rId1"/>
          <a:stretch/>
        </p:blipFill>
        <p:spPr>
          <a:xfrm>
            <a:off x="2062080" y="1057320"/>
            <a:ext cx="2729160" cy="3457440"/>
          </a:xfrm>
          <a:prstGeom prst="rect">
            <a:avLst/>
          </a:prstGeom>
          <a:ln w="0">
            <a:noFill/>
          </a:ln>
        </p:spPr>
      </p:pic>
      <p:grpSp>
        <p:nvGrpSpPr>
          <p:cNvPr id="83" name="Group 1"/>
          <p:cNvGrpSpPr/>
          <p:nvPr/>
        </p:nvGrpSpPr>
        <p:grpSpPr>
          <a:xfrm>
            <a:off x="1314360" y="5065560"/>
            <a:ext cx="4238640" cy="1914840"/>
            <a:chOff x="1314360" y="5065560"/>
            <a:chExt cx="4238640" cy="1914840"/>
          </a:xfrm>
        </p:grpSpPr>
        <p:pic>
          <p:nvPicPr>
            <p:cNvPr id="84" name="Picture 3" descr=""/>
            <p:cNvPicPr/>
            <p:nvPr/>
          </p:nvPicPr>
          <p:blipFill>
            <a:blip r:embed="rId2"/>
            <a:srcRect l="0" t="0" r="34940" b="0"/>
            <a:stretch/>
          </p:blipFill>
          <p:spPr>
            <a:xfrm>
              <a:off x="2714400" y="5065560"/>
              <a:ext cx="2838600" cy="1914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5" name="Picture 3" descr=""/>
            <p:cNvPicPr/>
            <p:nvPr/>
          </p:nvPicPr>
          <p:blipFill>
            <a:blip r:embed="rId3"/>
            <a:srcRect l="69219" t="0" r="0" b="0"/>
            <a:stretch/>
          </p:blipFill>
          <p:spPr>
            <a:xfrm>
              <a:off x="1314360" y="5065560"/>
              <a:ext cx="1342800" cy="19148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86" name="Text Box 7"/>
          <p:cNvSpPr/>
          <p:nvPr/>
        </p:nvSpPr>
        <p:spPr>
          <a:xfrm>
            <a:off x="1077840" y="4832280"/>
            <a:ext cx="25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7"/>
          <p:cNvSpPr/>
          <p:nvPr/>
        </p:nvSpPr>
        <p:spPr>
          <a:xfrm>
            <a:off x="1716120" y="725400"/>
            <a:ext cx="25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Text Box 6"/>
          <p:cNvSpPr/>
          <p:nvPr/>
        </p:nvSpPr>
        <p:spPr>
          <a:xfrm>
            <a:off x="2277720" y="31100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7"/>
          <p:cNvSpPr/>
          <p:nvPr/>
        </p:nvSpPr>
        <p:spPr>
          <a:xfrm>
            <a:off x="3673080" y="471636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13"/>
          <p:cNvSpPr/>
          <p:nvPr/>
        </p:nvSpPr>
        <p:spPr>
          <a:xfrm>
            <a:off x="1033560" y="4740120"/>
            <a:ext cx="28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1" name="Object 21"/>
          <p:cNvGraphicFramePr/>
          <p:nvPr/>
        </p:nvGraphicFramePr>
        <p:xfrm>
          <a:off x="2097000" y="5240160"/>
          <a:ext cx="1300320" cy="10256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92" name="Object 2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097000" y="5240160"/>
                    <a:ext cx="1300320" cy="1025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3" name="Object 22"/>
          <p:cNvGraphicFramePr/>
          <p:nvPr/>
        </p:nvGraphicFramePr>
        <p:xfrm>
          <a:off x="1204920" y="5272200"/>
          <a:ext cx="677880" cy="9936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94" name="Object 22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204920" y="5272200"/>
                    <a:ext cx="677880" cy="993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5" name="TextBox 11"/>
          <p:cNvSpPr/>
          <p:nvPr/>
        </p:nvSpPr>
        <p:spPr>
          <a:xfrm>
            <a:off x="1427040" y="5070600"/>
            <a:ext cx="59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AT" sz="800" spc="-1" strike="noStrike">
                <a:solidFill>
                  <a:srgbClr val="000000"/>
                </a:solidFill>
                <a:latin typeface="Arial"/>
                <a:ea typeface="Arial"/>
              </a:rPr>
              <a:t>CDKN1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11"/>
          <p:cNvSpPr/>
          <p:nvPr/>
        </p:nvSpPr>
        <p:spPr>
          <a:xfrm>
            <a:off x="2308320" y="5070600"/>
            <a:ext cx="67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AT" sz="800" spc="-1" strike="noStrike">
                <a:solidFill>
                  <a:srgbClr val="000000"/>
                </a:solidFill>
                <a:latin typeface="Arial"/>
                <a:ea typeface="Arial"/>
              </a:rPr>
              <a:t>CDKN1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7" name="Group 41"/>
          <p:cNvGrpSpPr/>
          <p:nvPr/>
        </p:nvGrpSpPr>
        <p:grpSpPr>
          <a:xfrm>
            <a:off x="3983040" y="5010120"/>
            <a:ext cx="1795320" cy="1202760"/>
            <a:chOff x="3983040" y="5010120"/>
            <a:chExt cx="1795320" cy="1202760"/>
          </a:xfrm>
        </p:grpSpPr>
        <p:grpSp>
          <p:nvGrpSpPr>
            <p:cNvPr id="98" name="Group 33"/>
            <p:cNvGrpSpPr/>
            <p:nvPr/>
          </p:nvGrpSpPr>
          <p:grpSpPr>
            <a:xfrm>
              <a:off x="3983040" y="5158080"/>
              <a:ext cx="1795320" cy="1054800"/>
              <a:chOff x="3983040" y="5158080"/>
              <a:chExt cx="1795320" cy="1054800"/>
            </a:xfrm>
          </p:grpSpPr>
          <p:graphicFrame>
            <p:nvGraphicFramePr>
              <p:cNvPr id="99" name="Object 23"/>
              <p:cNvGraphicFramePr/>
              <p:nvPr/>
            </p:nvGraphicFramePr>
            <p:xfrm>
              <a:off x="4688640" y="5162760"/>
              <a:ext cx="1089720" cy="1050120"/>
            </p:xfrm>
            <a:graphic>
              <a:graphicData uri="http://schemas.openxmlformats.org/presentationml/2006/ole">
                <p:oleObj r:id="rId5" spid="">
                  <p:embed/>
                  <p:pic>
                    <p:nvPicPr>
                      <p:cNvPr id="100" name="Object 23" descr=""/>
                      <p:cNvPicPr/>
                      <p:nvPr/>
                    </p:nvPicPr>
                    <p:blipFill>
                      <a:blip r:embed="rId6"/>
                      <a:stretch/>
                    </p:blipFill>
                    <p:spPr>
                      <a:xfrm>
                        <a:off x="4688640" y="5162760"/>
                        <a:ext cx="1089720" cy="10501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01" name="Object 24"/>
              <p:cNvGraphicFramePr/>
              <p:nvPr/>
            </p:nvGraphicFramePr>
            <p:xfrm>
              <a:off x="3983040" y="5158080"/>
              <a:ext cx="628920" cy="1053720"/>
            </p:xfrm>
            <a:graphic>
              <a:graphicData uri="http://schemas.openxmlformats.org/presentationml/2006/ole">
                <p:oleObj r:id="rId7" spid="">
                  <p:embed/>
                  <p:pic>
                    <p:nvPicPr>
                      <p:cNvPr id="102" name="Object 24" descr=""/>
                      <p:cNvPicPr/>
                      <p:nvPr/>
                    </p:nvPicPr>
                    <p:blipFill>
                      <a:blip r:embed="rId8"/>
                      <a:stretch/>
                    </p:blipFill>
                    <p:spPr>
                      <a:xfrm>
                        <a:off x="3983040" y="5158080"/>
                        <a:ext cx="628920" cy="10537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</p:grpSp>
        <p:sp>
          <p:nvSpPr>
            <p:cNvPr id="103" name="TextBox 11"/>
            <p:cNvSpPr/>
            <p:nvPr/>
          </p:nvSpPr>
          <p:spPr>
            <a:xfrm>
              <a:off x="4200480" y="5010120"/>
              <a:ext cx="529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de-AT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CND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Box 11"/>
            <p:cNvSpPr/>
            <p:nvPr/>
          </p:nvSpPr>
          <p:spPr>
            <a:xfrm>
              <a:off x="4929120" y="5010120"/>
              <a:ext cx="581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de-AT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CL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5" name="Group 39"/>
          <p:cNvGrpSpPr/>
          <p:nvPr/>
        </p:nvGrpSpPr>
        <p:grpSpPr>
          <a:xfrm>
            <a:off x="2635200" y="3227400"/>
            <a:ext cx="1282680" cy="1301760"/>
            <a:chOff x="2635200" y="3227400"/>
            <a:chExt cx="1282680" cy="1301760"/>
          </a:xfrm>
        </p:grpSpPr>
        <p:graphicFrame>
          <p:nvGraphicFramePr>
            <p:cNvPr id="106" name="Object 25"/>
            <p:cNvGraphicFramePr/>
            <p:nvPr/>
          </p:nvGraphicFramePr>
          <p:xfrm>
            <a:off x="2635200" y="3398760"/>
            <a:ext cx="1282680" cy="113040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107" name="Object 25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2635200" y="3398760"/>
                      <a:ext cx="1282680" cy="1130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08" name="TextBox 11"/>
            <p:cNvSpPr/>
            <p:nvPr/>
          </p:nvSpPr>
          <p:spPr>
            <a:xfrm>
              <a:off x="2982600" y="3227400"/>
              <a:ext cx="466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de-AT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IT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9" name="Text Box 13"/>
          <p:cNvSpPr/>
          <p:nvPr/>
        </p:nvSpPr>
        <p:spPr>
          <a:xfrm>
            <a:off x="1176480" y="1063800"/>
            <a:ext cx="28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16"/>
          <p:cNvSpPr/>
          <p:nvPr/>
        </p:nvSpPr>
        <p:spPr>
          <a:xfrm>
            <a:off x="33480" y="6665760"/>
            <a:ext cx="679428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5. AURKA regulates MITF and the associated transcriptional program.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 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(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A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) The indicated melanoma cells were treated with AURKA-i (MLN8237) at different concentrations followed by assessment of MITF levels by immunoblotting. (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B-D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) UACC-62 cells were treated as indicated for 18 hours followed by quantification of 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MITF 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(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B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), 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CDKN1A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 and 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CDKN1B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 (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C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), and 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CCND1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 and </a:t>
            </a:r>
            <a:r>
              <a:rPr b="0" i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BCL-2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 (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D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) mRNA levels by qRT-PCR. MLN8237 (1 µM) was used. All error bars indicate ±S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1" name="Picture 20" descr=""/>
          <p:cNvPicPr/>
          <p:nvPr/>
        </p:nvPicPr>
        <p:blipFill>
          <a:blip r:embed="rId11"/>
          <a:stretch/>
        </p:blipFill>
        <p:spPr>
          <a:xfrm>
            <a:off x="1386000" y="1400040"/>
            <a:ext cx="4624200" cy="1281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17T10:15:25Z</dcterms:created>
  <dc:creator>ebi</dc:creator>
  <dc:description/>
  <dc:language>en-US</dc:language>
  <cp:lastModifiedBy>ravikumar.s</cp:lastModifiedBy>
  <dcterms:modified xsi:type="dcterms:W3CDTF">2016-03-04T15:59:05Z</dcterms:modified>
  <cp:revision>150</cp:revision>
  <dc:subject/>
  <dc:title>Slide 1</dc:title>
</cp:coreProperties>
</file>